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2" userDrawn="1">
          <p15:clr>
            <a:srgbClr val="A4A3A4"/>
          </p15:clr>
        </p15:guide>
        <p15:guide id="2" pos="38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85" d="100"/>
          <a:sy n="85" d="100"/>
        </p:scale>
        <p:origin x="156" y="48"/>
      </p:cViewPr>
      <p:guideLst>
        <p:guide orient="horz" pos="2132"/>
        <p:guide pos="3824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bleStyles" Target="tableStyles.xml"/><Relationship Id="rId14" Type="http://schemas.openxmlformats.org/officeDocument/2006/relationships/viewProps" Target="viewProps.xml"/><Relationship Id="rId13" Type="http://schemas.openxmlformats.org/officeDocument/2006/relationships/presProps" Target="presProps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tags" Target="../tags/tag63.xml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9" Type="http://schemas.openxmlformats.org/officeDocument/2006/relationships/image" Target="../media/image66.png"/><Relationship Id="rId8" Type="http://schemas.openxmlformats.org/officeDocument/2006/relationships/image" Target="../media/image65.png"/><Relationship Id="rId7" Type="http://schemas.openxmlformats.org/officeDocument/2006/relationships/image" Target="../media/image64.png"/><Relationship Id="rId6" Type="http://schemas.openxmlformats.org/officeDocument/2006/relationships/image" Target="../media/image63.png"/><Relationship Id="rId5" Type="http://schemas.openxmlformats.org/officeDocument/2006/relationships/image" Target="../media/image62.png"/><Relationship Id="rId4" Type="http://schemas.openxmlformats.org/officeDocument/2006/relationships/image" Target="../media/image61.png"/><Relationship Id="rId3" Type="http://schemas.openxmlformats.org/officeDocument/2006/relationships/image" Target="../media/image60.png"/><Relationship Id="rId2" Type="http://schemas.openxmlformats.org/officeDocument/2006/relationships/image" Target="../media/image59.png"/><Relationship Id="rId12" Type="http://schemas.openxmlformats.org/officeDocument/2006/relationships/slideLayout" Target="../slideLayouts/slideLayout1.xml"/><Relationship Id="rId11" Type="http://schemas.openxmlformats.org/officeDocument/2006/relationships/tags" Target="../tags/tag72.xml"/><Relationship Id="rId10" Type="http://schemas.openxmlformats.org/officeDocument/2006/relationships/image" Target="../media/image67.png"/><Relationship Id="rId1" Type="http://schemas.openxmlformats.org/officeDocument/2006/relationships/image" Target="../media/image58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14.png"/><Relationship Id="rId8" Type="http://schemas.openxmlformats.org/officeDocument/2006/relationships/image" Target="../media/image13.png"/><Relationship Id="rId7" Type="http://schemas.openxmlformats.org/officeDocument/2006/relationships/image" Target="../media/image12.png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2" Type="http://schemas.openxmlformats.org/officeDocument/2006/relationships/slideLayout" Target="../slideLayouts/slideLayout1.xml"/><Relationship Id="rId11" Type="http://schemas.openxmlformats.org/officeDocument/2006/relationships/tags" Target="../tags/tag64.xml"/><Relationship Id="rId10" Type="http://schemas.openxmlformats.org/officeDocument/2006/relationships/image" Target="../media/image15.png"/><Relationship Id="rId1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tags" Target="../tags/tag65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29.png"/><Relationship Id="rId8" Type="http://schemas.openxmlformats.org/officeDocument/2006/relationships/image" Target="../media/image28.png"/><Relationship Id="rId7" Type="http://schemas.openxmlformats.org/officeDocument/2006/relationships/image" Target="../media/image27.png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2" Type="http://schemas.openxmlformats.org/officeDocument/2006/relationships/slideLayout" Target="../slideLayouts/slideLayout1.xml"/><Relationship Id="rId11" Type="http://schemas.openxmlformats.org/officeDocument/2006/relationships/tags" Target="../tags/tag66.xml"/><Relationship Id="rId10" Type="http://schemas.openxmlformats.org/officeDocument/2006/relationships/image" Target="../media/image30.png"/><Relationship Id="rId1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tags" Target="../tags/tag67.xml"/><Relationship Id="rId5" Type="http://schemas.openxmlformats.org/officeDocument/2006/relationships/image" Target="../media/image35.png"/><Relationship Id="rId4" Type="http://schemas.openxmlformats.org/officeDocument/2006/relationships/image" Target="../media/image34.png"/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image" Target="../media/image31.png"/></Relationships>
</file>

<file path=ppt/slides/_rels/slide6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tags" Target="../tags/tag68.xml"/><Relationship Id="rId5" Type="http://schemas.openxmlformats.org/officeDocument/2006/relationships/image" Target="../media/image40.png"/><Relationship Id="rId4" Type="http://schemas.openxmlformats.org/officeDocument/2006/relationships/image" Target="../media/image39.png"/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image" Target="../media/image36.png"/></Relationships>
</file>

<file path=ppt/slides/_rels/slide7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tags" Target="../tags/tag69.xml"/><Relationship Id="rId5" Type="http://schemas.openxmlformats.org/officeDocument/2006/relationships/image" Target="../media/image45.png"/><Relationship Id="rId4" Type="http://schemas.openxmlformats.org/officeDocument/2006/relationships/image" Target="../media/image44.png"/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image" Target="../media/image41.png"/></Relationships>
</file>

<file path=ppt/slides/_rels/slide8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tags" Target="../tags/tag70.xml"/><Relationship Id="rId4" Type="http://schemas.openxmlformats.org/officeDocument/2006/relationships/image" Target="../media/image49.png"/><Relationship Id="rId3" Type="http://schemas.openxmlformats.org/officeDocument/2006/relationships/image" Target="../media/image48.png"/><Relationship Id="rId2" Type="http://schemas.openxmlformats.org/officeDocument/2006/relationships/image" Target="../media/image47.png"/><Relationship Id="rId1" Type="http://schemas.openxmlformats.org/officeDocument/2006/relationships/image" Target="../media/image46.png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tags" Target="../tags/tag71.xml"/><Relationship Id="rId8" Type="http://schemas.openxmlformats.org/officeDocument/2006/relationships/image" Target="../media/image57.png"/><Relationship Id="rId7" Type="http://schemas.openxmlformats.org/officeDocument/2006/relationships/image" Target="../media/image56.png"/><Relationship Id="rId6" Type="http://schemas.openxmlformats.org/officeDocument/2006/relationships/image" Target="../media/image55.png"/><Relationship Id="rId5" Type="http://schemas.openxmlformats.org/officeDocument/2006/relationships/image" Target="../media/image54.png"/><Relationship Id="rId4" Type="http://schemas.openxmlformats.org/officeDocument/2006/relationships/image" Target="../media/image53.png"/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0" Type="http://schemas.openxmlformats.org/officeDocument/2006/relationships/slideLayout" Target="../slideLayouts/slideLayout1.xml"/><Relationship Id="rId1" Type="http://schemas.openxmlformats.org/officeDocument/2006/relationships/image" Target="../media/image5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3406" y="3859586"/>
            <a:ext cx="5052498" cy="1569856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617855" y="6184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Figure 1A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2380" y="1954530"/>
            <a:ext cx="3185160" cy="294894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14085" y="252428"/>
            <a:ext cx="2963545" cy="121475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1893055" y="3299534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913374" y="3764822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921475" y="4215759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4"/>
          <a:srcRect t="6818"/>
          <a:stretch>
            <a:fillRect/>
          </a:stretch>
        </p:blipFill>
        <p:spPr>
          <a:xfrm rot="10800000">
            <a:off x="6757428" y="1657409"/>
            <a:ext cx="2750820" cy="46863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57428" y="2274629"/>
            <a:ext cx="2750820" cy="1395095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6524503" y="1411738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6534027" y="2096736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6543085" y="3745072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2" name="矩形 1"/>
          <p:cNvSpPr/>
          <p:nvPr/>
        </p:nvSpPr>
        <p:spPr>
          <a:xfrm>
            <a:off x="6961337" y="1572318"/>
            <a:ext cx="2343001" cy="437846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" name="矩形 2"/>
          <p:cNvSpPr/>
          <p:nvPr/>
        </p:nvSpPr>
        <p:spPr>
          <a:xfrm>
            <a:off x="6927999" y="2902036"/>
            <a:ext cx="2343001" cy="437846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6919622" y="4415720"/>
            <a:ext cx="2343001" cy="437846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custDataLst>
      <p:tags r:id="rId6"/>
    </p:custData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-50165" y="1548765"/>
            <a:ext cx="5866765" cy="388366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795020" y="652145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5H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67400" y="1151890"/>
            <a:ext cx="5225415" cy="154368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09920" y="2904490"/>
            <a:ext cx="2057400" cy="38862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rcRect t="16883"/>
          <a:stretch>
            <a:fillRect/>
          </a:stretch>
        </p:blipFill>
        <p:spPr>
          <a:xfrm>
            <a:off x="6792595" y="2835910"/>
            <a:ext cx="2343785" cy="513715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109920" y="3489302"/>
            <a:ext cx="2050415" cy="88011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38950" y="3517900"/>
            <a:ext cx="2443480" cy="958850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7012270" y="2904490"/>
            <a:ext cx="1835820" cy="3886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9184206" y="2933471"/>
            <a:ext cx="1835820" cy="3886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6792595" y="3606800"/>
            <a:ext cx="2159000" cy="6521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9184206" y="3532274"/>
            <a:ext cx="1958006" cy="65197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3" name="组合 22"/>
          <p:cNvGrpSpPr/>
          <p:nvPr/>
        </p:nvGrpSpPr>
        <p:grpSpPr>
          <a:xfrm>
            <a:off x="9184206" y="4436576"/>
            <a:ext cx="2293620" cy="837882"/>
            <a:chOff x="9184206" y="4694629"/>
            <a:chExt cx="2293620" cy="788570"/>
          </a:xfrm>
        </p:grpSpPr>
        <p:pic>
          <p:nvPicPr>
            <p:cNvPr id="17" name="图片 16"/>
            <p:cNvPicPr>
              <a:picLocks noChangeAspect="1"/>
            </p:cNvPicPr>
            <p:nvPr/>
          </p:nvPicPr>
          <p:blipFill>
            <a:blip r:embed="rId7"/>
            <a:srcRect t="18657" b="19744"/>
            <a:stretch>
              <a:fillRect/>
            </a:stretch>
          </p:blipFill>
          <p:spPr>
            <a:xfrm>
              <a:off x="9184206" y="4694629"/>
              <a:ext cx="2293620" cy="788570"/>
            </a:xfrm>
            <a:prstGeom prst="rect">
              <a:avLst/>
            </a:prstGeom>
          </p:spPr>
        </p:pic>
        <p:sp>
          <p:nvSpPr>
            <p:cNvPr id="20" name="矩形 19"/>
            <p:cNvSpPr/>
            <p:nvPr/>
          </p:nvSpPr>
          <p:spPr>
            <a:xfrm>
              <a:off x="9409531" y="4886624"/>
              <a:ext cx="1835820" cy="38862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5" name="组合 24"/>
          <p:cNvGrpSpPr/>
          <p:nvPr/>
        </p:nvGrpSpPr>
        <p:grpSpPr>
          <a:xfrm>
            <a:off x="6657340" y="5481256"/>
            <a:ext cx="2388235" cy="742770"/>
            <a:chOff x="6657340" y="5739310"/>
            <a:chExt cx="2388235" cy="742770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657340" y="5774055"/>
              <a:ext cx="2388235" cy="708025"/>
            </a:xfrm>
            <a:prstGeom prst="rect">
              <a:avLst/>
            </a:prstGeom>
          </p:spPr>
        </p:pic>
        <p:sp>
          <p:nvSpPr>
            <p:cNvPr id="21" name="矩形 20"/>
            <p:cNvSpPr/>
            <p:nvPr/>
          </p:nvSpPr>
          <p:spPr>
            <a:xfrm>
              <a:off x="6920004" y="5739310"/>
              <a:ext cx="1958006" cy="65197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4" name="组合 23"/>
          <p:cNvGrpSpPr/>
          <p:nvPr/>
        </p:nvGrpSpPr>
        <p:grpSpPr>
          <a:xfrm>
            <a:off x="9282163" y="5512878"/>
            <a:ext cx="1963188" cy="775494"/>
            <a:chOff x="9204132" y="5757074"/>
            <a:chExt cx="1963188" cy="775494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9256605" y="5914713"/>
              <a:ext cx="1910715" cy="617855"/>
            </a:xfrm>
            <a:prstGeom prst="rect">
              <a:avLst/>
            </a:prstGeom>
          </p:spPr>
        </p:pic>
        <p:sp>
          <p:nvSpPr>
            <p:cNvPr id="22" name="矩形 21"/>
            <p:cNvSpPr/>
            <p:nvPr/>
          </p:nvSpPr>
          <p:spPr>
            <a:xfrm>
              <a:off x="9204132" y="5757074"/>
              <a:ext cx="1958006" cy="65197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6" name="文本框 25"/>
          <p:cNvSpPr txBox="1"/>
          <p:nvPr/>
        </p:nvSpPr>
        <p:spPr>
          <a:xfrm>
            <a:off x="1045973" y="3361240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040732" y="3853899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1040733" y="4372835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034375" y="4758342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④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6366827" y="2631902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6375402" y="3427253"/>
            <a:ext cx="6758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6366827" y="4250238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6361243" y="5224620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④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8893906" y="3301970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⑥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8922376" y="2604504"/>
            <a:ext cx="5191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⑤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8899277" y="4183361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⑦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8891443" y="5475510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⑧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3300097" y="3861998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⑥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3300097" y="3351609"/>
            <a:ext cx="5191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⑤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3300097" y="4308274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⑦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3300097" y="4716630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⑧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pic>
        <p:nvPicPr>
          <p:cNvPr id="48" name="图片 47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1953" y="4583744"/>
            <a:ext cx="2159778" cy="500965"/>
          </a:xfrm>
          <a:prstGeom prst="rect">
            <a:avLst/>
          </a:prstGeom>
        </p:spPr>
      </p:pic>
      <p:sp>
        <p:nvSpPr>
          <p:cNvPr id="49" name="矩形 48"/>
          <p:cNvSpPr/>
          <p:nvPr/>
        </p:nvSpPr>
        <p:spPr>
          <a:xfrm>
            <a:off x="6838366" y="4672512"/>
            <a:ext cx="2084009" cy="5009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custDataLst>
      <p:tags r:id="rId1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75590" y="2272665"/>
            <a:ext cx="4023995" cy="240601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617855" y="6184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</a:rPr>
              <a:t>Figure 1F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08625" y="618490"/>
            <a:ext cx="4958715" cy="110807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67294" y="2974229"/>
            <a:ext cx="2221230" cy="119761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46110" y="2023745"/>
            <a:ext cx="2366010" cy="78613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293580" y="4340131"/>
            <a:ext cx="2362200" cy="77724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90255" y="5315585"/>
            <a:ext cx="2221865" cy="7747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40555" y="2974975"/>
            <a:ext cx="3712845" cy="1198880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295900" y="2023745"/>
            <a:ext cx="2857500" cy="85344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69230" y="4257040"/>
            <a:ext cx="2827020" cy="97536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071110" y="5315585"/>
            <a:ext cx="3025140" cy="1386840"/>
          </a:xfrm>
          <a:prstGeom prst="rect">
            <a:avLst/>
          </a:prstGeom>
        </p:spPr>
      </p:pic>
      <p:sp>
        <p:nvSpPr>
          <p:cNvPr id="38" name="文本框 37"/>
          <p:cNvSpPr txBox="1"/>
          <p:nvPr/>
        </p:nvSpPr>
        <p:spPr>
          <a:xfrm>
            <a:off x="688890" y="2975223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927515" y="1872863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699225" y="3375340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4346665" y="2810190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699272" y="3713044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4998857" y="4113094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699313" y="4112801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④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4815383" y="5117371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④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2359521" y="2978777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⑤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2359432" y="3378575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⑥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8112532" y="2883275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⑥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8113891" y="1872607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⑤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2352132" y="3753412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⑦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8106502" y="4183942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⑦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2361687" y="4112817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⑧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8114152" y="5141517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⑧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5487035" y="3439160"/>
            <a:ext cx="1727835" cy="57594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/>
        </p:nvSpPr>
        <p:spPr>
          <a:xfrm>
            <a:off x="5555620" y="2267892"/>
            <a:ext cx="2343001" cy="57594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8482019" y="2242001"/>
            <a:ext cx="1985322" cy="57594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8425409" y="3201132"/>
            <a:ext cx="1985322" cy="57594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/>
          <p:cNvSpPr/>
          <p:nvPr/>
        </p:nvSpPr>
        <p:spPr>
          <a:xfrm>
            <a:off x="8397014" y="4282436"/>
            <a:ext cx="1985322" cy="57594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8577464" y="5484004"/>
            <a:ext cx="1985322" cy="57594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5487035" y="4224938"/>
            <a:ext cx="2411586" cy="57594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/>
          <p:cNvSpPr/>
          <p:nvPr/>
        </p:nvSpPr>
        <p:spPr>
          <a:xfrm>
            <a:off x="5377887" y="5606091"/>
            <a:ext cx="2411586" cy="57594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custDataLst>
      <p:tags r:id="rId1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723265" y="693420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3A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86986" y="1411619"/>
            <a:ext cx="5039995" cy="464312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90030" y="1262380"/>
            <a:ext cx="3355340" cy="97345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30060" y="2901950"/>
            <a:ext cx="3120390" cy="72199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30060" y="3780155"/>
            <a:ext cx="3221355" cy="73977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16420" y="4697095"/>
            <a:ext cx="3167380" cy="774065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1660525" y="2870122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609449" y="2735096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643748" y="3931421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620243" y="3623929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1644229" y="4910507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6674699" y="4561276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6899961" y="3068630"/>
            <a:ext cx="3315514" cy="3886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>
            <a:off x="6938767" y="3853945"/>
            <a:ext cx="3386753" cy="707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7031306" y="4910507"/>
            <a:ext cx="3240267" cy="5009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custDataLst>
      <p:tags r:id="rId6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824602" y="1101450"/>
            <a:ext cx="2484120" cy="54864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85339" y="1699497"/>
            <a:ext cx="2411542" cy="1533969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47767" y="5211800"/>
            <a:ext cx="2437790" cy="1441982"/>
          </a:xfrm>
          <a:prstGeom prst="rect">
            <a:avLst/>
          </a:prstGeom>
        </p:spPr>
      </p:pic>
      <p:pic>
        <p:nvPicPr>
          <p:cNvPr id="46" name="图片 45"/>
          <p:cNvPicPr>
            <a:picLocks noChangeAspect="1"/>
          </p:cNvPicPr>
          <p:nvPr/>
        </p:nvPicPr>
        <p:blipFill>
          <a:blip r:embed="rId4"/>
          <a:srcRect l="16233"/>
          <a:stretch>
            <a:fillRect/>
          </a:stretch>
        </p:blipFill>
        <p:spPr>
          <a:xfrm>
            <a:off x="8390124" y="3324129"/>
            <a:ext cx="3748313" cy="1409701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8491" y="2695288"/>
            <a:ext cx="5073671" cy="260223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795020" y="652145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3D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30" name="图片 29"/>
          <p:cNvPicPr>
            <a:picLocks noChangeAspect="1"/>
          </p:cNvPicPr>
          <p:nvPr/>
        </p:nvPicPr>
        <p:blipFill>
          <a:blip r:embed="rId6"/>
          <a:srcRect r="8165" b="18197"/>
          <a:stretch>
            <a:fillRect/>
          </a:stretch>
        </p:blipFill>
        <p:spPr>
          <a:xfrm>
            <a:off x="5833807" y="3306158"/>
            <a:ext cx="2092864" cy="1491391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96000" y="84163"/>
            <a:ext cx="4781432" cy="969843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8"/>
          <a:srcRect r="11697"/>
          <a:stretch>
            <a:fillRect/>
          </a:stretch>
        </p:blipFill>
        <p:spPr>
          <a:xfrm>
            <a:off x="8700944" y="4964416"/>
            <a:ext cx="2346960" cy="968375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560467" y="1187728"/>
            <a:ext cx="2209800" cy="556260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532733" y="1891119"/>
            <a:ext cx="2529840" cy="1409700"/>
          </a:xfrm>
          <a:prstGeom prst="rect">
            <a:avLst/>
          </a:prstGeom>
        </p:spPr>
      </p:pic>
      <p:sp>
        <p:nvSpPr>
          <p:cNvPr id="37" name="文本框 36"/>
          <p:cNvSpPr txBox="1"/>
          <p:nvPr/>
        </p:nvSpPr>
        <p:spPr>
          <a:xfrm>
            <a:off x="5169302" y="4709731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④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5169302" y="2877185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5169302" y="1931425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5170402" y="1003361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8169097" y="798503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⑤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8210633" y="1650090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⑥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8188408" y="3255823"/>
            <a:ext cx="603250" cy="43307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⑦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8374787" y="4716645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⑧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7" name="矩形 46"/>
          <p:cNvSpPr/>
          <p:nvPr/>
        </p:nvSpPr>
        <p:spPr>
          <a:xfrm>
            <a:off x="6186160" y="1054275"/>
            <a:ext cx="2219389" cy="3886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8" name="矩形 47"/>
          <p:cNvSpPr/>
          <p:nvPr/>
        </p:nvSpPr>
        <p:spPr>
          <a:xfrm>
            <a:off x="5901357" y="2131480"/>
            <a:ext cx="2247302" cy="5751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9" name="矩形 48"/>
          <p:cNvSpPr/>
          <p:nvPr/>
        </p:nvSpPr>
        <p:spPr>
          <a:xfrm>
            <a:off x="6048578" y="4283879"/>
            <a:ext cx="1768477" cy="3563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0" name="矩形 49"/>
          <p:cNvSpPr/>
          <p:nvPr/>
        </p:nvSpPr>
        <p:spPr>
          <a:xfrm>
            <a:off x="6037765" y="6104972"/>
            <a:ext cx="2074984" cy="3563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1" name="矩形 50"/>
          <p:cNvSpPr/>
          <p:nvPr/>
        </p:nvSpPr>
        <p:spPr>
          <a:xfrm>
            <a:off x="8550364" y="1079076"/>
            <a:ext cx="2084009" cy="5009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 dirty="0"/>
          </a:p>
        </p:txBody>
      </p:sp>
      <p:sp>
        <p:nvSpPr>
          <p:cNvPr id="52" name="矩形 51"/>
          <p:cNvSpPr/>
          <p:nvPr/>
        </p:nvSpPr>
        <p:spPr>
          <a:xfrm>
            <a:off x="8758861" y="2520465"/>
            <a:ext cx="2154828" cy="6725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 dirty="0"/>
          </a:p>
        </p:txBody>
      </p:sp>
      <p:sp>
        <p:nvSpPr>
          <p:cNvPr id="53" name="矩形 52"/>
          <p:cNvSpPr/>
          <p:nvPr/>
        </p:nvSpPr>
        <p:spPr>
          <a:xfrm>
            <a:off x="8528271" y="4028979"/>
            <a:ext cx="1856572" cy="4330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 dirty="0"/>
          </a:p>
        </p:txBody>
      </p:sp>
      <p:sp>
        <p:nvSpPr>
          <p:cNvPr id="54" name="矩形 53"/>
          <p:cNvSpPr/>
          <p:nvPr/>
        </p:nvSpPr>
        <p:spPr>
          <a:xfrm>
            <a:off x="8822439" y="5056251"/>
            <a:ext cx="2152957" cy="4330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 dirty="0"/>
          </a:p>
        </p:txBody>
      </p:sp>
      <p:sp>
        <p:nvSpPr>
          <p:cNvPr id="62" name="文本框 61"/>
          <p:cNvSpPr txBox="1"/>
          <p:nvPr/>
        </p:nvSpPr>
        <p:spPr>
          <a:xfrm>
            <a:off x="504507" y="4797549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④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497269" y="4476915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64" name="文本框 63"/>
          <p:cNvSpPr txBox="1"/>
          <p:nvPr/>
        </p:nvSpPr>
        <p:spPr>
          <a:xfrm>
            <a:off x="497269" y="3912624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65" name="文本框 64"/>
          <p:cNvSpPr txBox="1"/>
          <p:nvPr/>
        </p:nvSpPr>
        <p:spPr>
          <a:xfrm>
            <a:off x="526418" y="3483835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66" name="文本框 65"/>
          <p:cNvSpPr txBox="1"/>
          <p:nvPr/>
        </p:nvSpPr>
        <p:spPr>
          <a:xfrm>
            <a:off x="2660941" y="3485755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⑤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67" name="文本框 66"/>
          <p:cNvSpPr txBox="1"/>
          <p:nvPr/>
        </p:nvSpPr>
        <p:spPr>
          <a:xfrm>
            <a:off x="2662894" y="3989820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⑥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68" name="文本框 67"/>
          <p:cNvSpPr txBox="1"/>
          <p:nvPr/>
        </p:nvSpPr>
        <p:spPr>
          <a:xfrm>
            <a:off x="2661083" y="4532807"/>
            <a:ext cx="603250" cy="43307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⑦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69" name="文本框 68"/>
          <p:cNvSpPr txBox="1"/>
          <p:nvPr/>
        </p:nvSpPr>
        <p:spPr>
          <a:xfrm>
            <a:off x="2673561" y="4832395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⑧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</p:spTree>
    <p:custDataLst>
      <p:tags r:id="rId11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219835" y="2062480"/>
            <a:ext cx="2901315" cy="275336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795020" y="652145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3I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73825" y="1101725"/>
            <a:ext cx="2670175" cy="118808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91020" y="5469255"/>
            <a:ext cx="2146935" cy="115316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91020" y="2371090"/>
            <a:ext cx="1958340" cy="160528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91020" y="4023995"/>
            <a:ext cx="1958340" cy="1397635"/>
          </a:xfrm>
          <a:prstGeom prst="rect">
            <a:avLst/>
          </a:prstGeom>
        </p:spPr>
      </p:pic>
      <p:sp>
        <p:nvSpPr>
          <p:cNvPr id="38" name="文本框 37"/>
          <p:cNvSpPr txBox="1"/>
          <p:nvPr/>
        </p:nvSpPr>
        <p:spPr>
          <a:xfrm>
            <a:off x="1760770" y="2973953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6584865" y="2290058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1760945" y="3624260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6585040" y="3880165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1760992" y="4123254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647317" y="5327214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5" name="矩形 4"/>
          <p:cNvSpPr/>
          <p:nvPr/>
        </p:nvSpPr>
        <p:spPr>
          <a:xfrm>
            <a:off x="6822766" y="2863194"/>
            <a:ext cx="2180990" cy="3886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/>
          <p:cNvSpPr/>
          <p:nvPr/>
        </p:nvSpPr>
        <p:spPr>
          <a:xfrm>
            <a:off x="6938768" y="4213819"/>
            <a:ext cx="2014498" cy="520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/>
          <p:cNvSpPr/>
          <p:nvPr/>
        </p:nvSpPr>
        <p:spPr>
          <a:xfrm>
            <a:off x="7003257" y="5555020"/>
            <a:ext cx="2140743" cy="5009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custDataLst>
      <p:tags r:id="rId6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180465" y="2139950"/>
            <a:ext cx="3124200" cy="227076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795020" y="652145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4A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70345" y="1256665"/>
            <a:ext cx="3103245" cy="95885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23685" y="3429000"/>
            <a:ext cx="2903220" cy="73914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70345" y="2451735"/>
            <a:ext cx="2956560" cy="9525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34150" y="4298315"/>
            <a:ext cx="3139440" cy="161544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1633432" y="3167651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211147" y="2215786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633432" y="3535597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310207" y="3340652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632968" y="3854458"/>
            <a:ext cx="12600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272278" y="4100203"/>
            <a:ext cx="12600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6742998" y="2393998"/>
            <a:ext cx="2591736" cy="3886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6938768" y="3602347"/>
            <a:ext cx="2395966" cy="520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6902280" y="4600034"/>
            <a:ext cx="2624625" cy="5009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custDataLst>
      <p:tags r:id="rId6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89025" y="2574290"/>
            <a:ext cx="3368040" cy="268224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795020" y="652145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4D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36337" y="1707506"/>
            <a:ext cx="2809240" cy="11303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11340" y="4954270"/>
            <a:ext cx="2771140" cy="92773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91020" y="3816350"/>
            <a:ext cx="2807970" cy="93980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73239" y="3088640"/>
            <a:ext cx="2601739" cy="570865"/>
          </a:xfrm>
          <a:prstGeom prst="rect">
            <a:avLst/>
          </a:prstGeom>
        </p:spPr>
      </p:pic>
      <p:sp>
        <p:nvSpPr>
          <p:cNvPr id="38" name="文本框 37"/>
          <p:cNvSpPr txBox="1"/>
          <p:nvPr/>
        </p:nvSpPr>
        <p:spPr>
          <a:xfrm>
            <a:off x="1584875" y="3788658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645825" y="2924423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1585050" y="4263705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6635840" y="3659820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6625727" y="4756349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0" name="矩形 9"/>
          <p:cNvSpPr/>
          <p:nvPr/>
        </p:nvSpPr>
        <p:spPr>
          <a:xfrm>
            <a:off x="7141295" y="3186747"/>
            <a:ext cx="2445880" cy="3886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7187794" y="3960194"/>
            <a:ext cx="2287183" cy="520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7141295" y="5110542"/>
            <a:ext cx="2234119" cy="5409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>
            <a:off x="1597568" y="4675167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</p:spTree>
    <p:custDataLst>
      <p:tags r:id="rId6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026795" y="2553335"/>
            <a:ext cx="3368040" cy="234696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795020" y="652145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5B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79146" y="1574103"/>
            <a:ext cx="3738245" cy="103124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75869" y="3687019"/>
            <a:ext cx="3670169" cy="1031240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1675977" y="3664221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5943301" y="2503124"/>
            <a:ext cx="6189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675977" y="4140752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5943301" y="3564461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6375869" y="2815652"/>
            <a:ext cx="3681578" cy="71294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6846143" y="2703178"/>
            <a:ext cx="3021523" cy="7258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6776658" y="3803638"/>
            <a:ext cx="3091943" cy="7258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custDataLst>
      <p:tags r:id="rId5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76250" y="869950"/>
            <a:ext cx="5360670" cy="523303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795020" y="652145"/>
            <a:ext cx="609600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Figure 5D</a:t>
            </a:r>
            <a:endParaRPr lang="en-US" altLang="zh-CN" b="1"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60394" y="228239"/>
            <a:ext cx="4025900" cy="108966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22925" y="1359294"/>
            <a:ext cx="2377440" cy="92202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rcRect t="22029" b="20255"/>
          <a:stretch>
            <a:fillRect/>
          </a:stretch>
        </p:blipFill>
        <p:spPr>
          <a:xfrm>
            <a:off x="8026722" y="2335633"/>
            <a:ext cx="2415540" cy="94996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/>
          <a:srcRect t="59328"/>
          <a:stretch>
            <a:fillRect/>
          </a:stretch>
        </p:blipFill>
        <p:spPr>
          <a:xfrm>
            <a:off x="8036852" y="3371710"/>
            <a:ext cx="2324100" cy="62293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6"/>
          <a:srcRect l="2988"/>
          <a:stretch>
            <a:fillRect/>
          </a:stretch>
        </p:blipFill>
        <p:spPr>
          <a:xfrm>
            <a:off x="8110015" y="5536556"/>
            <a:ext cx="2521585" cy="661035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2866072" y="2626355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866071" y="3199390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853108" y="3701170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866071" y="4202950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④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2866071" y="5215119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⑥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866071" y="4704730"/>
            <a:ext cx="5191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⑤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7607294" y="1337033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①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7592319" y="2167376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②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7607294" y="3139857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③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7632753" y="3872618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④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7691674" y="5312858"/>
            <a:ext cx="5810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⑥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7683105" y="4519093"/>
            <a:ext cx="5191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2000" b="1" dirty="0">
                <a:solidFill>
                  <a:srgbClr val="FF0000"/>
                </a:solidFill>
              </a:rPr>
              <a:t>⑤</a:t>
            </a:r>
            <a:endParaRPr lang="zh-CN" altLang="en-US" sz="2000" b="1" dirty="0">
              <a:solidFill>
                <a:srgbClr val="FF0000"/>
              </a:solidFill>
            </a:endParaRPr>
          </a:p>
        </p:txBody>
      </p:sp>
      <p:pic>
        <p:nvPicPr>
          <p:cNvPr id="22" name="图片 21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10015" y="4755276"/>
            <a:ext cx="2521585" cy="661035"/>
          </a:xfrm>
          <a:prstGeom prst="rect">
            <a:avLst/>
          </a:prstGeom>
        </p:spPr>
      </p:pic>
      <p:pic>
        <p:nvPicPr>
          <p:cNvPr id="24" name="图片 23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5135" y="4092992"/>
            <a:ext cx="2521585" cy="550034"/>
          </a:xfrm>
          <a:prstGeom prst="rect">
            <a:avLst/>
          </a:prstGeom>
        </p:spPr>
      </p:pic>
      <p:sp>
        <p:nvSpPr>
          <p:cNvPr id="25" name="矩形 24"/>
          <p:cNvSpPr/>
          <p:nvPr/>
        </p:nvSpPr>
        <p:spPr>
          <a:xfrm>
            <a:off x="8336186" y="1917163"/>
            <a:ext cx="1835820" cy="3886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/>
          <p:cNvSpPr/>
          <p:nvPr/>
        </p:nvSpPr>
        <p:spPr>
          <a:xfrm>
            <a:off x="8349575" y="2619321"/>
            <a:ext cx="1958006" cy="520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/>
          <p:cNvSpPr/>
          <p:nvPr/>
        </p:nvSpPr>
        <p:spPr>
          <a:xfrm>
            <a:off x="8202266" y="3531167"/>
            <a:ext cx="2084009" cy="50096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/>
          <p:cNvSpPr/>
          <p:nvPr/>
        </p:nvSpPr>
        <p:spPr>
          <a:xfrm>
            <a:off x="8036852" y="4106858"/>
            <a:ext cx="2521585" cy="44536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/>
          <p:cNvSpPr/>
          <p:nvPr/>
        </p:nvSpPr>
        <p:spPr>
          <a:xfrm>
            <a:off x="8126465" y="4823367"/>
            <a:ext cx="2348895" cy="520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>
            <a:off x="8272699" y="5598460"/>
            <a:ext cx="2192375" cy="5205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custDataLst>
      <p:tags r:id="rId9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7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8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9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1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2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4</Words>
  <Application>WPS 演示</Application>
  <PresentationFormat>宽屏</PresentationFormat>
  <Paragraphs>208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9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阿白</cp:lastModifiedBy>
  <cp:revision>169</cp:revision>
  <dcterms:created xsi:type="dcterms:W3CDTF">2019-06-19T02:08:00Z</dcterms:created>
  <dcterms:modified xsi:type="dcterms:W3CDTF">2024-11-21T10:19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8912</vt:lpwstr>
  </property>
  <property fmtid="{D5CDD505-2E9C-101B-9397-08002B2CF9AE}" pid="3" name="ICV">
    <vt:lpwstr>8E5079508FFB4DB28A27246AA418DFBB_13</vt:lpwstr>
  </property>
</Properties>
</file>